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EA281-758B-41D7-A3A6-69A16DDE26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C0C78-A544-4666-ACF7-E413A1B2FC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1A0C9-7DF0-4500-9D4A-E7A7C50D49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15323-8D90-4E6A-946C-A2974E5021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-280080"/>
            <a:ext cx="8229600" cy="828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4036760" indent="0" algn="ctr">
              <a:spcBef>
                <a:spcPts val="799"/>
              </a:spcBef>
              <a:buNone/>
              <a:tabLst>
                <a:tab algn="l" pos="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354D3-A01B-4E42-993F-BE16F8DF93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E0A20-4B60-48D9-B802-9D77965173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78FCF-D562-42C7-A75B-FC5C7D9396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D1242-9C9C-4805-A2AC-8757FE6365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-1219320"/>
            <a:ext cx="8229600" cy="828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4036760" algn="ctr">
              <a:spcBef>
                <a:spcPts val="799"/>
              </a:spcBef>
              <a:tabLst>
                <a:tab algn="l" pos="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64C1D-2640-4AC7-B39D-542E502FEE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F32CE-06D8-43A8-A3C7-36449FA728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916E4-3E1E-4165-A4E7-73FD90ADE4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000BA-5628-4517-A7BF-F9B81A72FF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4440" indent="1016215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26120" indent="-279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18520" indent="-2239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66720" indent="-2239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2DCBC638-B48F-4D81-A50E-38423DB0DC22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Table 4" descr=""/>
          <p:cNvPicPr/>
          <p:nvPr/>
        </p:nvPicPr>
        <p:blipFill>
          <a:blip r:embed="rId1"/>
          <a:stretch/>
        </p:blipFill>
        <p:spPr>
          <a:xfrm>
            <a:off x="755640" y="219240"/>
            <a:ext cx="7858080" cy="605304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2"/>
          <p:cNvSpPr/>
          <p:nvPr/>
        </p:nvSpPr>
        <p:spPr>
          <a:xfrm>
            <a:off x="684360" y="6242040"/>
            <a:ext cx="8064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4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irwise comparison of digital Average Nucleotide Identity (ANI) values (%)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icrobispor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trains. Accession numbers of gene sequences used are shown in Table S1. Names used correspond to proposed taxonomic nam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28T09:07:46Z</dcterms:created>
  <dc:creator>VAIO</dc:creator>
  <dc:description/>
  <dc:language>en-US</dc:language>
  <cp:lastModifiedBy>Ricardo Machado</cp:lastModifiedBy>
  <dcterms:modified xsi:type="dcterms:W3CDTF">2024-06-26T12:02:52Z</dcterms:modified>
  <cp:revision>62</cp:revision>
  <dc:subject/>
  <dc:title>Présentation PowerPoint</dc:title>
</cp:coreProperties>
</file>